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BD3E1-6326-EAEA-AA4E-CB5664E98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D0526-7E61-4955-C031-9EA89C7562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F2C1E-38EC-8B8A-A7BE-EC040CC8A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AADFBC-C91F-5CBC-54B3-4C658984D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2583A-2352-4C78-86BB-774E98FF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3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E30B9-C040-132F-A1C4-8172C2800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3955B-6253-0D82-33E2-EDD1B7AB2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9A5B06-6F2A-5AE5-BE9C-DD07ECCCD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EE445-1621-FBC9-E792-43D760986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369B8-D6CE-27EA-7498-70B34AE5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165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880743-1CFB-AC71-338B-581B6772AD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10A6E-5332-4B08-0A1D-0DC9340D0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D51BD-84B4-7976-24EC-094010A8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31B07-82A2-E942-D06E-FFC5B0D4C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F6A76-8A1F-0688-EE6F-2078EAFE5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5551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3E397-79D5-30F9-A8C0-F3B86E15F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9610C1-7A98-BF48-A2AF-683559E1A8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0C6C2-AA6B-EB49-2583-64B6A950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CBB0F-A3C7-9429-880E-1FC64B19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91E40-FF26-D932-0EF5-9DDB64776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4221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3D8DF-71DA-8218-28D6-E7EC6AE7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B982E-D9EE-5835-E4D2-350C5DAE5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7E71C-5258-791B-3B64-E2B907D76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F21D1-DCBC-169D-670B-397A75146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D0D0E-E25F-538C-3CED-F7DB0DF3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4048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48F06-69FF-335F-695D-069C1F7E3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8A1050-E907-ECD8-155C-B94F5451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3AD79C-6A2F-E8B2-F807-B0ADDE505B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77B32F-B922-FC4C-493F-BEAC65115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B2302-3A20-03B8-4459-5A6B28CCC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91015-9DED-EFBE-5779-FCAC1CB78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648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F1416-A4CA-1D91-A003-DD2AAF435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432463-0B34-A737-65BB-F6FCAC0A3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113B73-E643-3092-50C9-836C9273E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147ECC-A451-466E-6ECB-1BE0B4500B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076EE5-C818-67D0-7AAB-5F69949C86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4E11F5-A3FB-42D9-A9D0-EFE909521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E7305-6858-DBEE-881F-76F2350B1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975E74-89A1-F5D2-9C87-2D7AC19DD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21310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F422E-8E1D-99B9-8B97-615EF683F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40BCA1-6E04-5962-505B-0E17E5405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16ACF3-E789-0CEA-3936-FD252725E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920E13-E437-C9B0-D852-7871D0942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3609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46A43E-DC2B-F021-58DF-61A3C4743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7B6230-23B2-2C7D-EF85-43A070D26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6D0EF5-46BD-D13C-40C4-DAFB822B6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0893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EBB53-9C26-4294-175C-1D460F48F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3EC4A-5007-1117-DB6C-A6FDF0C19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1B1829-202B-854C-33F2-199B1F880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DE4F7-D23B-5599-8F0A-7F2F10EF1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A92CD-7C91-D174-09C5-DCC96EDDC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75C27-6ECB-2D3D-5FF3-899FB7237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2407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417BF-3F53-8031-0BAB-23C8DE041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C1DF2B-D017-650A-D31A-5C0EA89939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728D31-D4E1-C75A-3FC7-5C3FD85F9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2918E-FA99-6637-6D5E-D507AFDC5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834CCB-EB1E-B7C4-EC23-60CCAECD9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C1839-D199-4C5B-37FF-3EA45899E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55112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C2DD5-AC70-7812-5B43-692C6DB30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DEA4D-A887-84F0-E009-C3EDB043B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6AF1-DFBC-6713-64CB-66907C7F6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10548-7A20-B0AA-D96C-22CF5C01C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D20B0-C719-0828-4564-ACEF025D2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28580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08B4644-87F7-4743-A2B2-89161964C4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326" t="-271" r="11047" b="52448"/>
          <a:stretch/>
        </p:blipFill>
        <p:spPr bwMode="auto">
          <a:xfrm>
            <a:off x="3729226" y="3264838"/>
            <a:ext cx="4826314" cy="2497363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3DC4C505-32E8-4570-856F-5EF9DB0AFABE}"/>
              </a:ext>
            </a:extLst>
          </p:cNvPr>
          <p:cNvSpPr/>
          <p:nvPr/>
        </p:nvSpPr>
        <p:spPr>
          <a:xfrm>
            <a:off x="4450549" y="4225681"/>
            <a:ext cx="2820003" cy="28783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249E14B-6A9A-4562-A02B-A5E65F855577}"/>
              </a:ext>
            </a:extLst>
          </p:cNvPr>
          <p:cNvSpPr txBox="1"/>
          <p:nvPr/>
        </p:nvSpPr>
        <p:spPr>
          <a:xfrm>
            <a:off x="7604589" y="4220148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P3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AC1163A-1A35-2AB1-E5FE-F90A5E55DC9C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4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27973ED-8BF6-EEFF-58F7-3A4896CEE599}"/>
              </a:ext>
            </a:extLst>
          </p:cNvPr>
          <p:cNvSpPr txBox="1"/>
          <p:nvPr/>
        </p:nvSpPr>
        <p:spPr>
          <a:xfrm rot="16200000">
            <a:off x="4494461" y="268307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E4FAE8D-B7B8-51B3-E27C-794F2F202DA4}"/>
              </a:ext>
            </a:extLst>
          </p:cNvPr>
          <p:cNvSpPr txBox="1"/>
          <p:nvPr/>
        </p:nvSpPr>
        <p:spPr>
          <a:xfrm rot="16200000">
            <a:off x="5132118" y="1473332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05C2273-A056-4488-1CD0-A26F27E92AD0}"/>
              </a:ext>
            </a:extLst>
          </p:cNvPr>
          <p:cNvSpPr txBox="1"/>
          <p:nvPr/>
        </p:nvSpPr>
        <p:spPr>
          <a:xfrm rot="16200000">
            <a:off x="4672578" y="2394449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52F6520-49DB-2885-644A-79BF67536FED}"/>
              </a:ext>
            </a:extLst>
          </p:cNvPr>
          <p:cNvSpPr txBox="1"/>
          <p:nvPr/>
        </p:nvSpPr>
        <p:spPr>
          <a:xfrm rot="16200000">
            <a:off x="5431867" y="2274075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25C4FE6-5905-2BC0-9C87-D47AA0ECA087}"/>
              </a:ext>
            </a:extLst>
          </p:cNvPr>
          <p:cNvSpPr txBox="1"/>
          <p:nvPr/>
        </p:nvSpPr>
        <p:spPr>
          <a:xfrm rot="16200000">
            <a:off x="5150256" y="2447199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B260445-A3B6-668A-09A5-E215FFC9D26C}"/>
              </a:ext>
            </a:extLst>
          </p:cNvPr>
          <p:cNvSpPr txBox="1"/>
          <p:nvPr/>
        </p:nvSpPr>
        <p:spPr>
          <a:xfrm rot="16200000">
            <a:off x="5592964" y="1519589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38CBA27-9F3A-5A1B-A485-3F264022F8CC}"/>
              </a:ext>
            </a:extLst>
          </p:cNvPr>
          <p:cNvCxnSpPr>
            <a:cxnSpLocks/>
          </p:cNvCxnSpPr>
          <p:nvPr/>
        </p:nvCxnSpPr>
        <p:spPr>
          <a:xfrm>
            <a:off x="4515154" y="302708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D20FBF8-8D83-CBFE-9C03-433E8EEA16AE}"/>
              </a:ext>
            </a:extLst>
          </p:cNvPr>
          <p:cNvCxnSpPr>
            <a:cxnSpLocks/>
          </p:cNvCxnSpPr>
          <p:nvPr/>
        </p:nvCxnSpPr>
        <p:spPr>
          <a:xfrm>
            <a:off x="4978980" y="302708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FBEC66F-5A3E-C761-BB19-62E96430A868}"/>
              </a:ext>
            </a:extLst>
          </p:cNvPr>
          <p:cNvCxnSpPr>
            <a:cxnSpLocks/>
          </p:cNvCxnSpPr>
          <p:nvPr/>
        </p:nvCxnSpPr>
        <p:spPr>
          <a:xfrm>
            <a:off x="5439825" y="302683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FBCA3A8-3A15-7BEA-246E-F37968912C98}"/>
              </a:ext>
            </a:extLst>
          </p:cNvPr>
          <p:cNvCxnSpPr>
            <a:cxnSpLocks/>
          </p:cNvCxnSpPr>
          <p:nvPr/>
        </p:nvCxnSpPr>
        <p:spPr>
          <a:xfrm>
            <a:off x="5894305" y="302683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7C8C7825-9318-9722-F899-752FD9B1F3B2}"/>
              </a:ext>
            </a:extLst>
          </p:cNvPr>
          <p:cNvCxnSpPr>
            <a:cxnSpLocks/>
          </p:cNvCxnSpPr>
          <p:nvPr/>
        </p:nvCxnSpPr>
        <p:spPr>
          <a:xfrm>
            <a:off x="6343954" y="302924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F5838780-E818-6BAD-9384-49DD28B6A801}"/>
              </a:ext>
            </a:extLst>
          </p:cNvPr>
          <p:cNvCxnSpPr>
            <a:cxnSpLocks/>
          </p:cNvCxnSpPr>
          <p:nvPr/>
        </p:nvCxnSpPr>
        <p:spPr>
          <a:xfrm>
            <a:off x="6801154" y="302683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607EE3C2-574B-64E8-4CE7-B0FF348F88DC}"/>
              </a:ext>
            </a:extLst>
          </p:cNvPr>
          <p:cNvSpPr txBox="1"/>
          <p:nvPr/>
        </p:nvSpPr>
        <p:spPr>
          <a:xfrm>
            <a:off x="3924914" y="3062752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5AB2E10-A3AC-51BF-1CB4-6178BF722BD7}"/>
              </a:ext>
            </a:extLst>
          </p:cNvPr>
          <p:cNvSpPr txBox="1"/>
          <p:nvPr/>
        </p:nvSpPr>
        <p:spPr>
          <a:xfrm>
            <a:off x="3544109" y="3342219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29B9366-231A-A72A-A948-68D45555B815}"/>
              </a:ext>
            </a:extLst>
          </p:cNvPr>
          <p:cNvSpPr txBox="1"/>
          <p:nvPr/>
        </p:nvSpPr>
        <p:spPr>
          <a:xfrm>
            <a:off x="4450549" y="3046026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CFF6CA6-F6CB-17CC-0FBA-3F3A3DB6EBF7}"/>
              </a:ext>
            </a:extLst>
          </p:cNvPr>
          <p:cNvSpPr txBox="1"/>
          <p:nvPr/>
        </p:nvSpPr>
        <p:spPr>
          <a:xfrm>
            <a:off x="4450549" y="3295412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A574FFF-A551-4641-88C5-9C3206A05EE2}"/>
              </a:ext>
            </a:extLst>
          </p:cNvPr>
          <p:cNvCxnSpPr>
            <a:cxnSpLocks/>
          </p:cNvCxnSpPr>
          <p:nvPr/>
        </p:nvCxnSpPr>
        <p:spPr>
          <a:xfrm>
            <a:off x="4138838" y="424787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36">
            <a:extLst>
              <a:ext uri="{FF2B5EF4-FFF2-40B4-BE49-F238E27FC236}">
                <a16:creationId xmlns:a16="http://schemas.microsoft.com/office/drawing/2014/main" id="{B6D0D383-1505-487F-82B9-B59E6F78A4FF}"/>
              </a:ext>
            </a:extLst>
          </p:cNvPr>
          <p:cNvSpPr txBox="1"/>
          <p:nvPr/>
        </p:nvSpPr>
        <p:spPr>
          <a:xfrm>
            <a:off x="3810452" y="41058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9B40CB1-81A9-45A0-B4CD-F5B29B9AF4E7}"/>
              </a:ext>
            </a:extLst>
          </p:cNvPr>
          <p:cNvCxnSpPr>
            <a:cxnSpLocks/>
          </p:cNvCxnSpPr>
          <p:nvPr/>
        </p:nvCxnSpPr>
        <p:spPr>
          <a:xfrm>
            <a:off x="4140652" y="445729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8">
            <a:extLst>
              <a:ext uri="{FF2B5EF4-FFF2-40B4-BE49-F238E27FC236}">
                <a16:creationId xmlns:a16="http://schemas.microsoft.com/office/drawing/2014/main" id="{1F2CDE62-3CD6-4FD1-BF2A-3EF20FAFD791}"/>
              </a:ext>
            </a:extLst>
          </p:cNvPr>
          <p:cNvSpPr txBox="1"/>
          <p:nvPr/>
        </p:nvSpPr>
        <p:spPr>
          <a:xfrm>
            <a:off x="3812266" y="43152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9EAF9DA-BF25-41EE-8C51-075774D50D8A}"/>
              </a:ext>
            </a:extLst>
          </p:cNvPr>
          <p:cNvCxnSpPr>
            <a:cxnSpLocks/>
          </p:cNvCxnSpPr>
          <p:nvPr/>
        </p:nvCxnSpPr>
        <p:spPr>
          <a:xfrm>
            <a:off x="4140121" y="397374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40">
            <a:extLst>
              <a:ext uri="{FF2B5EF4-FFF2-40B4-BE49-F238E27FC236}">
                <a16:creationId xmlns:a16="http://schemas.microsoft.com/office/drawing/2014/main" id="{70309426-856D-4AA9-A0E1-A64FA23EA01F}"/>
              </a:ext>
            </a:extLst>
          </p:cNvPr>
          <p:cNvSpPr txBox="1"/>
          <p:nvPr/>
        </p:nvSpPr>
        <p:spPr>
          <a:xfrm>
            <a:off x="3811735" y="383167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64853D1-D2AA-4555-9232-8F4B30CE5274}"/>
              </a:ext>
            </a:extLst>
          </p:cNvPr>
          <p:cNvCxnSpPr>
            <a:cxnSpLocks/>
          </p:cNvCxnSpPr>
          <p:nvPr/>
        </p:nvCxnSpPr>
        <p:spPr>
          <a:xfrm>
            <a:off x="4138647" y="3801451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44A5D88D-F615-4853-BFC0-329F609A7F01}"/>
              </a:ext>
            </a:extLst>
          </p:cNvPr>
          <p:cNvSpPr txBox="1"/>
          <p:nvPr/>
        </p:nvSpPr>
        <p:spPr>
          <a:xfrm>
            <a:off x="3810261" y="36526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ED009B97-457D-4873-A180-87F76ED0D6D6}"/>
              </a:ext>
            </a:extLst>
          </p:cNvPr>
          <p:cNvCxnSpPr>
            <a:cxnSpLocks/>
          </p:cNvCxnSpPr>
          <p:nvPr/>
        </p:nvCxnSpPr>
        <p:spPr>
          <a:xfrm>
            <a:off x="4138838" y="496221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8">
            <a:extLst>
              <a:ext uri="{FF2B5EF4-FFF2-40B4-BE49-F238E27FC236}">
                <a16:creationId xmlns:a16="http://schemas.microsoft.com/office/drawing/2014/main" id="{F43B81AB-3B63-411F-8B44-CF7662B6A8A3}"/>
              </a:ext>
            </a:extLst>
          </p:cNvPr>
          <p:cNvSpPr txBox="1"/>
          <p:nvPr/>
        </p:nvSpPr>
        <p:spPr>
          <a:xfrm>
            <a:off x="3810452" y="482014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96246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11</cp:revision>
  <dcterms:created xsi:type="dcterms:W3CDTF">2024-08-13T14:46:47Z</dcterms:created>
  <dcterms:modified xsi:type="dcterms:W3CDTF">2024-08-14T22:15:44Z</dcterms:modified>
</cp:coreProperties>
</file>